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588125" cy="4237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98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4110" y="693423"/>
            <a:ext cx="5599906" cy="1475117"/>
          </a:xfrm>
        </p:spPr>
        <p:txBody>
          <a:bodyPr anchor="b"/>
          <a:lstStyle>
            <a:lvl1pPr algn="ctr">
              <a:defRPr sz="37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3516" y="2225426"/>
            <a:ext cx="4941094" cy="1022970"/>
          </a:xfrm>
        </p:spPr>
        <p:txBody>
          <a:bodyPr/>
          <a:lstStyle>
            <a:lvl1pPr marL="0" indent="0" algn="ctr">
              <a:buNone/>
              <a:defRPr sz="1483"/>
            </a:lvl1pPr>
            <a:lvl2pPr marL="282458" indent="0" algn="ctr">
              <a:buNone/>
              <a:defRPr sz="1236"/>
            </a:lvl2pPr>
            <a:lvl3pPr marL="564916" indent="0" algn="ctr">
              <a:buNone/>
              <a:defRPr sz="1112"/>
            </a:lvl3pPr>
            <a:lvl4pPr marL="847374" indent="0" algn="ctr">
              <a:buNone/>
              <a:defRPr sz="988"/>
            </a:lvl4pPr>
            <a:lvl5pPr marL="1129833" indent="0" algn="ctr">
              <a:buNone/>
              <a:defRPr sz="988"/>
            </a:lvl5pPr>
            <a:lvl6pPr marL="1412291" indent="0" algn="ctr">
              <a:buNone/>
              <a:defRPr sz="988"/>
            </a:lvl6pPr>
            <a:lvl7pPr marL="1694749" indent="0" algn="ctr">
              <a:buNone/>
              <a:defRPr sz="988"/>
            </a:lvl7pPr>
            <a:lvl8pPr marL="1977207" indent="0" algn="ctr">
              <a:buNone/>
              <a:defRPr sz="988"/>
            </a:lvl8pPr>
            <a:lvl9pPr marL="2259665" indent="0" algn="ctr">
              <a:buNone/>
              <a:defRPr sz="9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8945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5168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14628" y="225583"/>
            <a:ext cx="1420564" cy="35906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2934" y="225583"/>
            <a:ext cx="4179342" cy="359069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3902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968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9503" y="1056318"/>
            <a:ext cx="5682258" cy="1762490"/>
          </a:xfrm>
        </p:spPr>
        <p:txBody>
          <a:bodyPr anchor="b"/>
          <a:lstStyle>
            <a:lvl1pPr>
              <a:defRPr sz="37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9503" y="2835482"/>
            <a:ext cx="5682258" cy="926852"/>
          </a:xfrm>
        </p:spPr>
        <p:txBody>
          <a:bodyPr/>
          <a:lstStyle>
            <a:lvl1pPr marL="0" indent="0">
              <a:buNone/>
              <a:defRPr sz="1483">
                <a:solidFill>
                  <a:schemeClr val="tx1"/>
                </a:solidFill>
              </a:defRPr>
            </a:lvl1pPr>
            <a:lvl2pPr marL="282458" indent="0">
              <a:buNone/>
              <a:defRPr sz="1236">
                <a:solidFill>
                  <a:schemeClr val="tx1">
                    <a:tint val="75000"/>
                  </a:schemeClr>
                </a:solidFill>
              </a:defRPr>
            </a:lvl2pPr>
            <a:lvl3pPr marL="564916" indent="0">
              <a:buNone/>
              <a:defRPr sz="1112">
                <a:solidFill>
                  <a:schemeClr val="tx1">
                    <a:tint val="75000"/>
                  </a:schemeClr>
                </a:solidFill>
              </a:defRPr>
            </a:lvl3pPr>
            <a:lvl4pPr marL="847374" indent="0">
              <a:buNone/>
              <a:defRPr sz="988">
                <a:solidFill>
                  <a:schemeClr val="tx1">
                    <a:tint val="75000"/>
                  </a:schemeClr>
                </a:solidFill>
              </a:defRPr>
            </a:lvl4pPr>
            <a:lvl5pPr marL="1129833" indent="0">
              <a:buNone/>
              <a:defRPr sz="988">
                <a:solidFill>
                  <a:schemeClr val="tx1">
                    <a:tint val="75000"/>
                  </a:schemeClr>
                </a:solidFill>
              </a:defRPr>
            </a:lvl5pPr>
            <a:lvl6pPr marL="1412291" indent="0">
              <a:buNone/>
              <a:defRPr sz="988">
                <a:solidFill>
                  <a:schemeClr val="tx1">
                    <a:tint val="75000"/>
                  </a:schemeClr>
                </a:solidFill>
              </a:defRPr>
            </a:lvl6pPr>
            <a:lvl7pPr marL="1694749" indent="0">
              <a:buNone/>
              <a:defRPr sz="988">
                <a:solidFill>
                  <a:schemeClr val="tx1">
                    <a:tint val="75000"/>
                  </a:schemeClr>
                </a:solidFill>
              </a:defRPr>
            </a:lvl7pPr>
            <a:lvl8pPr marL="1977207" indent="0">
              <a:buNone/>
              <a:defRPr sz="988">
                <a:solidFill>
                  <a:schemeClr val="tx1">
                    <a:tint val="75000"/>
                  </a:schemeClr>
                </a:solidFill>
              </a:defRPr>
            </a:lvl8pPr>
            <a:lvl9pPr marL="2259665" indent="0">
              <a:buNone/>
              <a:defRPr sz="9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93566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2934" y="1127915"/>
            <a:ext cx="2799953" cy="26883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35238" y="1127915"/>
            <a:ext cx="2799953" cy="26883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2411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792" y="225584"/>
            <a:ext cx="5682258" cy="81896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3793" y="1038663"/>
            <a:ext cx="2787085" cy="509033"/>
          </a:xfrm>
        </p:spPr>
        <p:txBody>
          <a:bodyPr anchor="b"/>
          <a:lstStyle>
            <a:lvl1pPr marL="0" indent="0">
              <a:buNone/>
              <a:defRPr sz="1483" b="1"/>
            </a:lvl1pPr>
            <a:lvl2pPr marL="282458" indent="0">
              <a:buNone/>
              <a:defRPr sz="1236" b="1"/>
            </a:lvl2pPr>
            <a:lvl3pPr marL="564916" indent="0">
              <a:buNone/>
              <a:defRPr sz="1112" b="1"/>
            </a:lvl3pPr>
            <a:lvl4pPr marL="847374" indent="0">
              <a:buNone/>
              <a:defRPr sz="988" b="1"/>
            </a:lvl4pPr>
            <a:lvl5pPr marL="1129833" indent="0">
              <a:buNone/>
              <a:defRPr sz="988" b="1"/>
            </a:lvl5pPr>
            <a:lvl6pPr marL="1412291" indent="0">
              <a:buNone/>
              <a:defRPr sz="988" b="1"/>
            </a:lvl6pPr>
            <a:lvl7pPr marL="1694749" indent="0">
              <a:buNone/>
              <a:defRPr sz="988" b="1"/>
            </a:lvl7pPr>
            <a:lvl8pPr marL="1977207" indent="0">
              <a:buNone/>
              <a:defRPr sz="988" b="1"/>
            </a:lvl8pPr>
            <a:lvl9pPr marL="2259665" indent="0">
              <a:buNone/>
              <a:defRPr sz="9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3793" y="1547696"/>
            <a:ext cx="2787085" cy="22764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35239" y="1038663"/>
            <a:ext cx="2800811" cy="509033"/>
          </a:xfrm>
        </p:spPr>
        <p:txBody>
          <a:bodyPr anchor="b"/>
          <a:lstStyle>
            <a:lvl1pPr marL="0" indent="0">
              <a:buNone/>
              <a:defRPr sz="1483" b="1"/>
            </a:lvl1pPr>
            <a:lvl2pPr marL="282458" indent="0">
              <a:buNone/>
              <a:defRPr sz="1236" b="1"/>
            </a:lvl2pPr>
            <a:lvl3pPr marL="564916" indent="0">
              <a:buNone/>
              <a:defRPr sz="1112" b="1"/>
            </a:lvl3pPr>
            <a:lvl4pPr marL="847374" indent="0">
              <a:buNone/>
              <a:defRPr sz="988" b="1"/>
            </a:lvl4pPr>
            <a:lvl5pPr marL="1129833" indent="0">
              <a:buNone/>
              <a:defRPr sz="988" b="1"/>
            </a:lvl5pPr>
            <a:lvl6pPr marL="1412291" indent="0">
              <a:buNone/>
              <a:defRPr sz="988" b="1"/>
            </a:lvl6pPr>
            <a:lvl7pPr marL="1694749" indent="0">
              <a:buNone/>
              <a:defRPr sz="988" b="1"/>
            </a:lvl7pPr>
            <a:lvl8pPr marL="1977207" indent="0">
              <a:buNone/>
              <a:defRPr sz="988" b="1"/>
            </a:lvl8pPr>
            <a:lvl9pPr marL="2259665" indent="0">
              <a:buNone/>
              <a:defRPr sz="9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35239" y="1547696"/>
            <a:ext cx="2800811" cy="22764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88692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18552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5880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792" y="282469"/>
            <a:ext cx="2124842" cy="988642"/>
          </a:xfrm>
        </p:spPr>
        <p:txBody>
          <a:bodyPr anchor="b"/>
          <a:lstStyle>
            <a:lvl1pPr>
              <a:defRPr sz="197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00811" y="610056"/>
            <a:ext cx="3335238" cy="3011043"/>
          </a:xfrm>
        </p:spPr>
        <p:txBody>
          <a:bodyPr/>
          <a:lstStyle>
            <a:lvl1pPr>
              <a:defRPr sz="1977"/>
            </a:lvl1pPr>
            <a:lvl2pPr>
              <a:defRPr sz="1730"/>
            </a:lvl2pPr>
            <a:lvl3pPr>
              <a:defRPr sz="1483"/>
            </a:lvl3pPr>
            <a:lvl4pPr>
              <a:defRPr sz="1236"/>
            </a:lvl4pPr>
            <a:lvl5pPr>
              <a:defRPr sz="1236"/>
            </a:lvl5pPr>
            <a:lvl6pPr>
              <a:defRPr sz="1236"/>
            </a:lvl6pPr>
            <a:lvl7pPr>
              <a:defRPr sz="1236"/>
            </a:lvl7pPr>
            <a:lvl8pPr>
              <a:defRPr sz="1236"/>
            </a:lvl8pPr>
            <a:lvl9pPr>
              <a:defRPr sz="123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3792" y="1271111"/>
            <a:ext cx="2124842" cy="2354891"/>
          </a:xfrm>
        </p:spPr>
        <p:txBody>
          <a:bodyPr/>
          <a:lstStyle>
            <a:lvl1pPr marL="0" indent="0">
              <a:buNone/>
              <a:defRPr sz="988"/>
            </a:lvl1pPr>
            <a:lvl2pPr marL="282458" indent="0">
              <a:buNone/>
              <a:defRPr sz="865"/>
            </a:lvl2pPr>
            <a:lvl3pPr marL="564916" indent="0">
              <a:buNone/>
              <a:defRPr sz="741"/>
            </a:lvl3pPr>
            <a:lvl4pPr marL="847374" indent="0">
              <a:buNone/>
              <a:defRPr sz="618"/>
            </a:lvl4pPr>
            <a:lvl5pPr marL="1129833" indent="0">
              <a:buNone/>
              <a:defRPr sz="618"/>
            </a:lvl5pPr>
            <a:lvl6pPr marL="1412291" indent="0">
              <a:buNone/>
              <a:defRPr sz="618"/>
            </a:lvl6pPr>
            <a:lvl7pPr marL="1694749" indent="0">
              <a:buNone/>
              <a:defRPr sz="618"/>
            </a:lvl7pPr>
            <a:lvl8pPr marL="1977207" indent="0">
              <a:buNone/>
              <a:defRPr sz="618"/>
            </a:lvl8pPr>
            <a:lvl9pPr marL="2259665" indent="0">
              <a:buNone/>
              <a:defRPr sz="61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71507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792" y="282469"/>
            <a:ext cx="2124842" cy="988642"/>
          </a:xfrm>
        </p:spPr>
        <p:txBody>
          <a:bodyPr anchor="b"/>
          <a:lstStyle>
            <a:lvl1pPr>
              <a:defRPr sz="197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00811" y="610056"/>
            <a:ext cx="3335238" cy="3011043"/>
          </a:xfrm>
        </p:spPr>
        <p:txBody>
          <a:bodyPr anchor="t"/>
          <a:lstStyle>
            <a:lvl1pPr marL="0" indent="0">
              <a:buNone/>
              <a:defRPr sz="1977"/>
            </a:lvl1pPr>
            <a:lvl2pPr marL="282458" indent="0">
              <a:buNone/>
              <a:defRPr sz="1730"/>
            </a:lvl2pPr>
            <a:lvl3pPr marL="564916" indent="0">
              <a:buNone/>
              <a:defRPr sz="1483"/>
            </a:lvl3pPr>
            <a:lvl4pPr marL="847374" indent="0">
              <a:buNone/>
              <a:defRPr sz="1236"/>
            </a:lvl4pPr>
            <a:lvl5pPr marL="1129833" indent="0">
              <a:buNone/>
              <a:defRPr sz="1236"/>
            </a:lvl5pPr>
            <a:lvl6pPr marL="1412291" indent="0">
              <a:buNone/>
              <a:defRPr sz="1236"/>
            </a:lvl6pPr>
            <a:lvl7pPr marL="1694749" indent="0">
              <a:buNone/>
              <a:defRPr sz="1236"/>
            </a:lvl7pPr>
            <a:lvl8pPr marL="1977207" indent="0">
              <a:buNone/>
              <a:defRPr sz="1236"/>
            </a:lvl8pPr>
            <a:lvl9pPr marL="2259665" indent="0">
              <a:buNone/>
              <a:defRPr sz="123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3792" y="1271111"/>
            <a:ext cx="2124842" cy="2354891"/>
          </a:xfrm>
        </p:spPr>
        <p:txBody>
          <a:bodyPr/>
          <a:lstStyle>
            <a:lvl1pPr marL="0" indent="0">
              <a:buNone/>
              <a:defRPr sz="988"/>
            </a:lvl1pPr>
            <a:lvl2pPr marL="282458" indent="0">
              <a:buNone/>
              <a:defRPr sz="865"/>
            </a:lvl2pPr>
            <a:lvl3pPr marL="564916" indent="0">
              <a:buNone/>
              <a:defRPr sz="741"/>
            </a:lvl3pPr>
            <a:lvl4pPr marL="847374" indent="0">
              <a:buNone/>
              <a:defRPr sz="618"/>
            </a:lvl4pPr>
            <a:lvl5pPr marL="1129833" indent="0">
              <a:buNone/>
              <a:defRPr sz="618"/>
            </a:lvl5pPr>
            <a:lvl6pPr marL="1412291" indent="0">
              <a:buNone/>
              <a:defRPr sz="618"/>
            </a:lvl6pPr>
            <a:lvl7pPr marL="1694749" indent="0">
              <a:buNone/>
              <a:defRPr sz="618"/>
            </a:lvl7pPr>
            <a:lvl8pPr marL="1977207" indent="0">
              <a:buNone/>
              <a:defRPr sz="618"/>
            </a:lvl8pPr>
            <a:lvl9pPr marL="2259665" indent="0">
              <a:buNone/>
              <a:defRPr sz="61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88430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2934" y="225584"/>
            <a:ext cx="5682258" cy="8189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2934" y="1127915"/>
            <a:ext cx="5682258" cy="26883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2934" y="3927107"/>
            <a:ext cx="1482328" cy="2255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80E46-D557-4937-B6EE-80C47B3105B5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2317" y="3927107"/>
            <a:ext cx="2223492" cy="2255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2863" y="3927107"/>
            <a:ext cx="1482328" cy="2255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C38948-FB6E-4F58-B88C-052AC7022FD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16260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64916" rtl="0" eaLnBrk="1" latinLnBrk="0" hangingPunct="1">
        <a:lnSpc>
          <a:spcPct val="90000"/>
        </a:lnSpc>
        <a:spcBef>
          <a:spcPct val="0"/>
        </a:spcBef>
        <a:buNone/>
        <a:defRPr sz="27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1229" indent="-141229" algn="l" defTabSz="564916" rtl="0" eaLnBrk="1" latinLnBrk="0" hangingPunct="1">
        <a:lnSpc>
          <a:spcPct val="90000"/>
        </a:lnSpc>
        <a:spcBef>
          <a:spcPts val="618"/>
        </a:spcBef>
        <a:buFont typeface="Arial" panose="020B0604020202020204" pitchFamily="34" charset="0"/>
        <a:buChar char="•"/>
        <a:defRPr sz="1730" kern="1200">
          <a:solidFill>
            <a:schemeClr val="tx1"/>
          </a:solidFill>
          <a:latin typeface="+mn-lt"/>
          <a:ea typeface="+mn-ea"/>
          <a:cs typeface="+mn-cs"/>
        </a:defRPr>
      </a:lvl1pPr>
      <a:lvl2pPr marL="423687" indent="-141229" algn="l" defTabSz="564916" rtl="0" eaLnBrk="1" latinLnBrk="0" hangingPunct="1">
        <a:lnSpc>
          <a:spcPct val="90000"/>
        </a:lnSpc>
        <a:spcBef>
          <a:spcPts val="309"/>
        </a:spcBef>
        <a:buFont typeface="Arial" panose="020B0604020202020204" pitchFamily="34" charset="0"/>
        <a:buChar char="•"/>
        <a:defRPr sz="1483" kern="1200">
          <a:solidFill>
            <a:schemeClr val="tx1"/>
          </a:solidFill>
          <a:latin typeface="+mn-lt"/>
          <a:ea typeface="+mn-ea"/>
          <a:cs typeface="+mn-cs"/>
        </a:defRPr>
      </a:lvl2pPr>
      <a:lvl3pPr marL="706145" indent="-141229" algn="l" defTabSz="564916" rtl="0" eaLnBrk="1" latinLnBrk="0" hangingPunct="1">
        <a:lnSpc>
          <a:spcPct val="90000"/>
        </a:lnSpc>
        <a:spcBef>
          <a:spcPts val="309"/>
        </a:spcBef>
        <a:buFont typeface="Arial" panose="020B0604020202020204" pitchFamily="34" charset="0"/>
        <a:buChar char="•"/>
        <a:defRPr sz="1236" kern="1200">
          <a:solidFill>
            <a:schemeClr val="tx1"/>
          </a:solidFill>
          <a:latin typeface="+mn-lt"/>
          <a:ea typeface="+mn-ea"/>
          <a:cs typeface="+mn-cs"/>
        </a:defRPr>
      </a:lvl3pPr>
      <a:lvl4pPr marL="988604" indent="-141229" algn="l" defTabSz="564916" rtl="0" eaLnBrk="1" latinLnBrk="0" hangingPunct="1">
        <a:lnSpc>
          <a:spcPct val="90000"/>
        </a:lnSpc>
        <a:spcBef>
          <a:spcPts val="309"/>
        </a:spcBef>
        <a:buFont typeface="Arial" panose="020B0604020202020204" pitchFamily="34" charset="0"/>
        <a:buChar char="•"/>
        <a:defRPr sz="1112" kern="1200">
          <a:solidFill>
            <a:schemeClr val="tx1"/>
          </a:solidFill>
          <a:latin typeface="+mn-lt"/>
          <a:ea typeface="+mn-ea"/>
          <a:cs typeface="+mn-cs"/>
        </a:defRPr>
      </a:lvl4pPr>
      <a:lvl5pPr marL="1271062" indent="-141229" algn="l" defTabSz="564916" rtl="0" eaLnBrk="1" latinLnBrk="0" hangingPunct="1">
        <a:lnSpc>
          <a:spcPct val="90000"/>
        </a:lnSpc>
        <a:spcBef>
          <a:spcPts val="309"/>
        </a:spcBef>
        <a:buFont typeface="Arial" panose="020B0604020202020204" pitchFamily="34" charset="0"/>
        <a:buChar char="•"/>
        <a:defRPr sz="1112" kern="1200">
          <a:solidFill>
            <a:schemeClr val="tx1"/>
          </a:solidFill>
          <a:latin typeface="+mn-lt"/>
          <a:ea typeface="+mn-ea"/>
          <a:cs typeface="+mn-cs"/>
        </a:defRPr>
      </a:lvl5pPr>
      <a:lvl6pPr marL="1553520" indent="-141229" algn="l" defTabSz="564916" rtl="0" eaLnBrk="1" latinLnBrk="0" hangingPunct="1">
        <a:lnSpc>
          <a:spcPct val="90000"/>
        </a:lnSpc>
        <a:spcBef>
          <a:spcPts val="309"/>
        </a:spcBef>
        <a:buFont typeface="Arial" panose="020B0604020202020204" pitchFamily="34" charset="0"/>
        <a:buChar char="•"/>
        <a:defRPr sz="1112" kern="1200">
          <a:solidFill>
            <a:schemeClr val="tx1"/>
          </a:solidFill>
          <a:latin typeface="+mn-lt"/>
          <a:ea typeface="+mn-ea"/>
          <a:cs typeface="+mn-cs"/>
        </a:defRPr>
      </a:lvl6pPr>
      <a:lvl7pPr marL="1835978" indent="-141229" algn="l" defTabSz="564916" rtl="0" eaLnBrk="1" latinLnBrk="0" hangingPunct="1">
        <a:lnSpc>
          <a:spcPct val="90000"/>
        </a:lnSpc>
        <a:spcBef>
          <a:spcPts val="309"/>
        </a:spcBef>
        <a:buFont typeface="Arial" panose="020B0604020202020204" pitchFamily="34" charset="0"/>
        <a:buChar char="•"/>
        <a:defRPr sz="1112" kern="1200">
          <a:solidFill>
            <a:schemeClr val="tx1"/>
          </a:solidFill>
          <a:latin typeface="+mn-lt"/>
          <a:ea typeface="+mn-ea"/>
          <a:cs typeface="+mn-cs"/>
        </a:defRPr>
      </a:lvl7pPr>
      <a:lvl8pPr marL="2118436" indent="-141229" algn="l" defTabSz="564916" rtl="0" eaLnBrk="1" latinLnBrk="0" hangingPunct="1">
        <a:lnSpc>
          <a:spcPct val="90000"/>
        </a:lnSpc>
        <a:spcBef>
          <a:spcPts val="309"/>
        </a:spcBef>
        <a:buFont typeface="Arial" panose="020B0604020202020204" pitchFamily="34" charset="0"/>
        <a:buChar char="•"/>
        <a:defRPr sz="1112" kern="1200">
          <a:solidFill>
            <a:schemeClr val="tx1"/>
          </a:solidFill>
          <a:latin typeface="+mn-lt"/>
          <a:ea typeface="+mn-ea"/>
          <a:cs typeface="+mn-cs"/>
        </a:defRPr>
      </a:lvl8pPr>
      <a:lvl9pPr marL="2400894" indent="-141229" algn="l" defTabSz="564916" rtl="0" eaLnBrk="1" latinLnBrk="0" hangingPunct="1">
        <a:lnSpc>
          <a:spcPct val="90000"/>
        </a:lnSpc>
        <a:spcBef>
          <a:spcPts val="309"/>
        </a:spcBef>
        <a:buFont typeface="Arial" panose="020B0604020202020204" pitchFamily="34" charset="0"/>
        <a:buChar char="•"/>
        <a:defRPr sz="11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64916" rtl="0" eaLnBrk="1" latinLnBrk="0" hangingPunct="1">
        <a:defRPr sz="1112" kern="1200">
          <a:solidFill>
            <a:schemeClr val="tx1"/>
          </a:solidFill>
          <a:latin typeface="+mn-lt"/>
          <a:ea typeface="+mn-ea"/>
          <a:cs typeface="+mn-cs"/>
        </a:defRPr>
      </a:lvl1pPr>
      <a:lvl2pPr marL="282458" algn="l" defTabSz="564916" rtl="0" eaLnBrk="1" latinLnBrk="0" hangingPunct="1">
        <a:defRPr sz="1112" kern="1200">
          <a:solidFill>
            <a:schemeClr val="tx1"/>
          </a:solidFill>
          <a:latin typeface="+mn-lt"/>
          <a:ea typeface="+mn-ea"/>
          <a:cs typeface="+mn-cs"/>
        </a:defRPr>
      </a:lvl2pPr>
      <a:lvl3pPr marL="564916" algn="l" defTabSz="564916" rtl="0" eaLnBrk="1" latinLnBrk="0" hangingPunct="1">
        <a:defRPr sz="1112" kern="1200">
          <a:solidFill>
            <a:schemeClr val="tx1"/>
          </a:solidFill>
          <a:latin typeface="+mn-lt"/>
          <a:ea typeface="+mn-ea"/>
          <a:cs typeface="+mn-cs"/>
        </a:defRPr>
      </a:lvl3pPr>
      <a:lvl4pPr marL="847374" algn="l" defTabSz="564916" rtl="0" eaLnBrk="1" latinLnBrk="0" hangingPunct="1">
        <a:defRPr sz="1112" kern="1200">
          <a:solidFill>
            <a:schemeClr val="tx1"/>
          </a:solidFill>
          <a:latin typeface="+mn-lt"/>
          <a:ea typeface="+mn-ea"/>
          <a:cs typeface="+mn-cs"/>
        </a:defRPr>
      </a:lvl4pPr>
      <a:lvl5pPr marL="1129833" algn="l" defTabSz="564916" rtl="0" eaLnBrk="1" latinLnBrk="0" hangingPunct="1">
        <a:defRPr sz="1112" kern="1200">
          <a:solidFill>
            <a:schemeClr val="tx1"/>
          </a:solidFill>
          <a:latin typeface="+mn-lt"/>
          <a:ea typeface="+mn-ea"/>
          <a:cs typeface="+mn-cs"/>
        </a:defRPr>
      </a:lvl5pPr>
      <a:lvl6pPr marL="1412291" algn="l" defTabSz="564916" rtl="0" eaLnBrk="1" latinLnBrk="0" hangingPunct="1">
        <a:defRPr sz="1112" kern="1200">
          <a:solidFill>
            <a:schemeClr val="tx1"/>
          </a:solidFill>
          <a:latin typeface="+mn-lt"/>
          <a:ea typeface="+mn-ea"/>
          <a:cs typeface="+mn-cs"/>
        </a:defRPr>
      </a:lvl6pPr>
      <a:lvl7pPr marL="1694749" algn="l" defTabSz="564916" rtl="0" eaLnBrk="1" latinLnBrk="0" hangingPunct="1">
        <a:defRPr sz="1112" kern="1200">
          <a:solidFill>
            <a:schemeClr val="tx1"/>
          </a:solidFill>
          <a:latin typeface="+mn-lt"/>
          <a:ea typeface="+mn-ea"/>
          <a:cs typeface="+mn-cs"/>
        </a:defRPr>
      </a:lvl7pPr>
      <a:lvl8pPr marL="1977207" algn="l" defTabSz="564916" rtl="0" eaLnBrk="1" latinLnBrk="0" hangingPunct="1">
        <a:defRPr sz="1112" kern="1200">
          <a:solidFill>
            <a:schemeClr val="tx1"/>
          </a:solidFill>
          <a:latin typeface="+mn-lt"/>
          <a:ea typeface="+mn-ea"/>
          <a:cs typeface="+mn-cs"/>
        </a:defRPr>
      </a:lvl8pPr>
      <a:lvl9pPr marL="2259665" algn="l" defTabSz="564916" rtl="0" eaLnBrk="1" latinLnBrk="0" hangingPunct="1">
        <a:defRPr sz="11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94C98398-9A05-488C-8B10-8AE60AAB223E}"/>
              </a:ext>
            </a:extLst>
          </p:cNvPr>
          <p:cNvGrpSpPr/>
          <p:nvPr/>
        </p:nvGrpSpPr>
        <p:grpSpPr>
          <a:xfrm>
            <a:off x="-1" y="-4297"/>
            <a:ext cx="6588000" cy="4238161"/>
            <a:chOff x="0" y="-4297"/>
            <a:chExt cx="6514717" cy="4238161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FCC08381-190C-4E90-B2D9-A135507F89D2}"/>
                </a:ext>
              </a:extLst>
            </p:cNvPr>
            <p:cNvSpPr/>
            <p:nvPr/>
          </p:nvSpPr>
          <p:spPr>
            <a:xfrm>
              <a:off x="6288" y="0"/>
              <a:ext cx="6508429" cy="423386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E4B9EDCC-6414-417A-8E8F-1FE7940F5796}"/>
                </a:ext>
              </a:extLst>
            </p:cNvPr>
            <p:cNvGrpSpPr/>
            <p:nvPr/>
          </p:nvGrpSpPr>
          <p:grpSpPr>
            <a:xfrm>
              <a:off x="707153" y="351926"/>
              <a:ext cx="2199183" cy="1670758"/>
              <a:chOff x="1925629" y="3580157"/>
              <a:chExt cx="2448923" cy="1598665"/>
            </a:xfrm>
          </p:grpSpPr>
          <p:pic>
            <p:nvPicPr>
              <p:cNvPr id="54" name="Google Shape;1249;p18" descr="Chart&#10;&#10;Description automatically generated">
                <a:extLst>
                  <a:ext uri="{FF2B5EF4-FFF2-40B4-BE49-F238E27FC236}">
                    <a16:creationId xmlns:a16="http://schemas.microsoft.com/office/drawing/2014/main" id="{762185D4-8AC1-4D10-B6E6-D4379C329660}"/>
                  </a:ext>
                </a:extLst>
              </p:cNvPr>
              <p:cNvPicPr preferRelativeResize="0"/>
              <p:nvPr/>
            </p:nvPicPr>
            <p:blipFill rotWithShape="1">
              <a:blip r:embed="rId2">
                <a:alphaModFix/>
              </a:blip>
              <a:srcRect l="4291" t="7012" r="1855" b="7506"/>
              <a:stretch/>
            </p:blipFill>
            <p:spPr>
              <a:xfrm>
                <a:off x="1925629" y="3580157"/>
                <a:ext cx="2448923" cy="1598665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55" name="Rectangle 54">
                <a:extLst>
                  <a:ext uri="{FF2B5EF4-FFF2-40B4-BE49-F238E27FC236}">
                    <a16:creationId xmlns:a16="http://schemas.microsoft.com/office/drawing/2014/main" id="{A6789F39-DCBD-46D6-AE34-30A8E9BD94F8}"/>
                  </a:ext>
                </a:extLst>
              </p:cNvPr>
              <p:cNvSpPr/>
              <p:nvPr/>
            </p:nvSpPr>
            <p:spPr>
              <a:xfrm>
                <a:off x="1962292" y="3586682"/>
                <a:ext cx="2400436" cy="1555414"/>
              </a:xfrm>
              <a:prstGeom prst="rect">
                <a:avLst/>
              </a:prstGeom>
              <a:noFill/>
              <a:ln w="19050">
                <a:solidFill>
                  <a:srgbClr val="59D8D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A61DD080-6F83-463A-A5CB-91DA521D11C2}"/>
                </a:ext>
              </a:extLst>
            </p:cNvPr>
            <p:cNvGrpSpPr/>
            <p:nvPr/>
          </p:nvGrpSpPr>
          <p:grpSpPr>
            <a:xfrm>
              <a:off x="429318" y="250592"/>
              <a:ext cx="2766743" cy="1954200"/>
              <a:chOff x="112206" y="1809919"/>
              <a:chExt cx="4149985" cy="2353110"/>
            </a:xfrm>
            <a:noFill/>
          </p:grpSpPr>
          <p:sp>
            <p:nvSpPr>
              <p:cNvPr id="52" name="Google Shape;1045;p14">
                <a:extLst>
                  <a:ext uri="{FF2B5EF4-FFF2-40B4-BE49-F238E27FC236}">
                    <a16:creationId xmlns:a16="http://schemas.microsoft.com/office/drawing/2014/main" id="{EBB7A0BF-AA0E-4912-9B69-00C027BE6D2D}"/>
                  </a:ext>
                </a:extLst>
              </p:cNvPr>
              <p:cNvSpPr txBox="1"/>
              <p:nvPr/>
            </p:nvSpPr>
            <p:spPr>
              <a:xfrm>
                <a:off x="112206" y="1809919"/>
                <a:ext cx="520422" cy="1935857"/>
              </a:xfrm>
              <a:prstGeom prst="rect">
                <a:avLst/>
              </a:prstGeom>
              <a:grpFill/>
              <a:ln>
                <a:noFill/>
              </a:ln>
            </p:spPr>
            <p:txBody>
              <a:bodyPr spcFirstLastPara="1" wrap="square" lIns="106260" tIns="53116" rIns="106260" bIns="53116" anchor="t" anchorCtr="0">
                <a:spAutoFit/>
              </a:bodyPr>
              <a:lstStyle/>
              <a:p>
                <a:pPr algn="r">
                  <a:lnSpc>
                    <a:spcPts val="930"/>
                  </a:lnSpc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  <a:endParaRPr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sz="700" b="1" baseline="300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>
                  <a:lnSpc>
                    <a:spcPts val="930"/>
                  </a:lnSpc>
                </a:pPr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Google Shape;1069;p14">
                <a:extLst>
                  <a:ext uri="{FF2B5EF4-FFF2-40B4-BE49-F238E27FC236}">
                    <a16:creationId xmlns:a16="http://schemas.microsoft.com/office/drawing/2014/main" id="{ED411738-0500-4351-AACB-172871EC8CFA}"/>
                  </a:ext>
                </a:extLst>
              </p:cNvPr>
              <p:cNvSpPr txBox="1"/>
              <p:nvPr/>
            </p:nvSpPr>
            <p:spPr>
              <a:xfrm>
                <a:off x="1044337" y="3904152"/>
                <a:ext cx="3217854" cy="258877"/>
              </a:xfrm>
              <a:prstGeom prst="rect">
                <a:avLst/>
              </a:prstGeom>
              <a:grpFill/>
              <a:ln>
                <a:noFill/>
              </a:ln>
            </p:spPr>
            <p:txBody>
              <a:bodyPr spcFirstLastPara="1" wrap="square" lIns="106260" tIns="53116" rIns="106260" bIns="53116" anchor="t" anchorCtr="0">
                <a:spAutoFit/>
              </a:bodyPr>
              <a:lstStyle/>
              <a:p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              40               60                80</a:t>
                </a:r>
                <a:endParaRPr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Google Shape;1253;p18">
              <a:extLst>
                <a:ext uri="{FF2B5EF4-FFF2-40B4-BE49-F238E27FC236}">
                  <a16:creationId xmlns:a16="http://schemas.microsoft.com/office/drawing/2014/main" id="{0FA65313-A4FC-412C-ADFE-629E73E06B1A}"/>
                </a:ext>
              </a:extLst>
            </p:cNvPr>
            <p:cNvSpPr txBox="1"/>
            <p:nvPr/>
          </p:nvSpPr>
          <p:spPr>
            <a:xfrm>
              <a:off x="0" y="921795"/>
              <a:ext cx="448601" cy="21499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sz="700" b="1" baseline="-250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0F3F931-757E-4A5A-AE86-F76906CB4D0F}"/>
                </a:ext>
              </a:extLst>
            </p:cNvPr>
            <p:cNvGrpSpPr/>
            <p:nvPr/>
          </p:nvGrpSpPr>
          <p:grpSpPr>
            <a:xfrm>
              <a:off x="3445865" y="3934422"/>
              <a:ext cx="2759186" cy="222512"/>
              <a:chOff x="1583052" y="6513931"/>
              <a:chExt cx="3580074" cy="231595"/>
            </a:xfrm>
          </p:grpSpPr>
          <p:grpSp>
            <p:nvGrpSpPr>
              <p:cNvPr id="47" name="Google Shape;968;p12">
                <a:extLst>
                  <a:ext uri="{FF2B5EF4-FFF2-40B4-BE49-F238E27FC236}">
                    <a16:creationId xmlns:a16="http://schemas.microsoft.com/office/drawing/2014/main" id="{56771A4F-942B-4833-BEB0-F0E89DAA4E16}"/>
                  </a:ext>
                </a:extLst>
              </p:cNvPr>
              <p:cNvGrpSpPr/>
              <p:nvPr/>
            </p:nvGrpSpPr>
            <p:grpSpPr>
              <a:xfrm>
                <a:off x="1583052" y="6539388"/>
                <a:ext cx="1656384" cy="184096"/>
                <a:chOff x="1911780" y="-1530167"/>
                <a:chExt cx="1609896" cy="160072"/>
              </a:xfrm>
            </p:grpSpPr>
            <p:sp>
              <p:nvSpPr>
                <p:cNvPr id="50" name="Google Shape;969;p12">
                  <a:extLst>
                    <a:ext uri="{FF2B5EF4-FFF2-40B4-BE49-F238E27FC236}">
                      <a16:creationId xmlns:a16="http://schemas.microsoft.com/office/drawing/2014/main" id="{1B295E06-3520-4547-8777-593396707C8B}"/>
                    </a:ext>
                  </a:extLst>
                </p:cNvPr>
                <p:cNvSpPr/>
                <p:nvPr/>
              </p:nvSpPr>
              <p:spPr>
                <a:xfrm>
                  <a:off x="3289564" y="-1529640"/>
                  <a:ext cx="232112" cy="159545"/>
                </a:xfrm>
                <a:prstGeom prst="rect">
                  <a:avLst/>
                </a:prstGeom>
                <a:solidFill>
                  <a:schemeClr val="bg1"/>
                </a:solidFill>
                <a:ln w="19050" cap="flat" cmpd="sng">
                  <a:solidFill>
                    <a:srgbClr val="FF8184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106260" tIns="53116" rIns="106260" bIns="53116" anchor="ctr" anchorCtr="0">
                  <a:noAutofit/>
                </a:bodyPr>
                <a:lstStyle/>
                <a:p>
                  <a:pPr algn="ctr"/>
                  <a:endParaRPr sz="700">
                    <a:solidFill>
                      <a:schemeClr val="lt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Google Shape;970;p12">
                  <a:extLst>
                    <a:ext uri="{FF2B5EF4-FFF2-40B4-BE49-F238E27FC236}">
                      <a16:creationId xmlns:a16="http://schemas.microsoft.com/office/drawing/2014/main" id="{808F4683-EA31-46D9-8180-280E224D6FB2}"/>
                    </a:ext>
                  </a:extLst>
                </p:cNvPr>
                <p:cNvSpPr/>
                <p:nvPr/>
              </p:nvSpPr>
              <p:spPr>
                <a:xfrm>
                  <a:off x="1911780" y="-1530167"/>
                  <a:ext cx="232112" cy="159545"/>
                </a:xfrm>
                <a:prstGeom prst="rect">
                  <a:avLst/>
                </a:prstGeom>
                <a:noFill/>
                <a:ln w="19050" cap="flat" cmpd="sng">
                  <a:solidFill>
                    <a:srgbClr val="59D8D5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106260" tIns="53116" rIns="106260" bIns="53116" anchor="ctr" anchorCtr="0">
                  <a:noAutofit/>
                </a:bodyPr>
                <a:lstStyle/>
                <a:p>
                  <a:pPr algn="ctr"/>
                  <a:endParaRPr sz="700">
                    <a:solidFill>
                      <a:schemeClr val="lt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8" name="Google Shape;972;p12">
                <a:extLst>
                  <a:ext uri="{FF2B5EF4-FFF2-40B4-BE49-F238E27FC236}">
                    <a16:creationId xmlns:a16="http://schemas.microsoft.com/office/drawing/2014/main" id="{FB964DA3-DFE3-49ED-93EC-001C127CFB16}"/>
                  </a:ext>
                </a:extLst>
              </p:cNvPr>
              <p:cNvSpPr txBox="1"/>
              <p:nvPr/>
            </p:nvSpPr>
            <p:spPr>
              <a:xfrm>
                <a:off x="3239437" y="6513931"/>
                <a:ext cx="1923689" cy="22376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06260" tIns="53116" rIns="106260" bIns="53116" anchor="t" anchorCtr="0">
                <a:spAutoFit/>
              </a:bodyPr>
              <a:lstStyle/>
              <a:p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untington's disease (HD)</a:t>
                </a:r>
                <a:endParaRPr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Google Shape;1013;p12">
                <a:extLst>
                  <a:ext uri="{FF2B5EF4-FFF2-40B4-BE49-F238E27FC236}">
                    <a16:creationId xmlns:a16="http://schemas.microsoft.com/office/drawing/2014/main" id="{8CFF6E9A-A7F5-4909-92F0-C59ED7E737BB}"/>
                  </a:ext>
                </a:extLst>
              </p:cNvPr>
              <p:cNvSpPr txBox="1"/>
              <p:nvPr/>
            </p:nvSpPr>
            <p:spPr>
              <a:xfrm>
                <a:off x="1782381" y="6521758"/>
                <a:ext cx="1786105" cy="22376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06260" tIns="53116" rIns="106260" bIns="53116" anchor="t" anchorCtr="0">
                <a:spAutoFit/>
              </a:bodyPr>
              <a:lstStyle/>
              <a:p>
                <a:r>
                  <a:rPr lang="en-US"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ild type (WT)</a:t>
                </a:r>
                <a:endParaRPr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3DC66B5-A3FF-43C8-8773-2100DD270069}"/>
                </a:ext>
              </a:extLst>
            </p:cNvPr>
            <p:cNvGrpSpPr/>
            <p:nvPr/>
          </p:nvGrpSpPr>
          <p:grpSpPr>
            <a:xfrm>
              <a:off x="708024" y="2203190"/>
              <a:ext cx="2328192" cy="1853717"/>
              <a:chOff x="692831" y="2432485"/>
              <a:chExt cx="2280875" cy="1690242"/>
            </a:xfrm>
            <a:noFill/>
          </p:grpSpPr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2511FEF8-9333-4B1D-9AC3-44961FE12D3E}"/>
                  </a:ext>
                </a:extLst>
              </p:cNvPr>
              <p:cNvGrpSpPr/>
              <p:nvPr/>
            </p:nvGrpSpPr>
            <p:grpSpPr>
              <a:xfrm>
                <a:off x="692831" y="2432485"/>
                <a:ext cx="2280875" cy="1690242"/>
                <a:chOff x="439320" y="4077368"/>
                <a:chExt cx="2361349" cy="1255114"/>
              </a:xfrm>
              <a:grpFill/>
            </p:grpSpPr>
            <p:pic>
              <p:nvPicPr>
                <p:cNvPr id="45" name="Google Shape;1250;p18" descr="Chart&#10;&#10;Description automatically generated">
                  <a:extLst>
                    <a:ext uri="{FF2B5EF4-FFF2-40B4-BE49-F238E27FC236}">
                      <a16:creationId xmlns:a16="http://schemas.microsoft.com/office/drawing/2014/main" id="{8D9B6B9C-4DDE-4BBF-90C0-79F162CBC07C}"/>
                    </a:ext>
                  </a:extLst>
                </p:cNvPr>
                <p:cNvPicPr preferRelativeResize="0"/>
                <p:nvPr/>
              </p:nvPicPr>
              <p:blipFill rotWithShape="1">
                <a:blip r:embed="rId3">
                  <a:alphaModFix/>
                </a:blip>
                <a:srcRect l="4488" t="7295" b="7037"/>
                <a:stretch/>
              </p:blipFill>
              <p:spPr>
                <a:xfrm>
                  <a:off x="439320" y="4077368"/>
                  <a:ext cx="2280639" cy="1146614"/>
                </a:xfrm>
                <a:prstGeom prst="rect">
                  <a:avLst/>
                </a:prstGeom>
                <a:grpFill/>
                <a:ln>
                  <a:noFill/>
                </a:ln>
              </p:spPr>
            </p:pic>
            <p:sp>
              <p:nvSpPr>
                <p:cNvPr id="46" name="Google Shape;1069;p14">
                  <a:extLst>
                    <a:ext uri="{FF2B5EF4-FFF2-40B4-BE49-F238E27FC236}">
                      <a16:creationId xmlns:a16="http://schemas.microsoft.com/office/drawing/2014/main" id="{84FC4E9F-FA7D-4DDF-838C-2F5619C72ECE}"/>
                    </a:ext>
                  </a:extLst>
                </p:cNvPr>
                <p:cNvSpPr txBox="1"/>
                <p:nvPr/>
              </p:nvSpPr>
              <p:spPr>
                <a:xfrm>
                  <a:off x="582026" y="5186916"/>
                  <a:ext cx="2218643" cy="145566"/>
                </a:xfrm>
                <a:prstGeom prst="rect">
                  <a:avLst/>
                </a:prstGeom>
                <a:grpFill/>
                <a:ln>
                  <a:noFill/>
                </a:ln>
              </p:spPr>
              <p:txBody>
                <a:bodyPr spcFirstLastPara="1" wrap="square" lIns="106260" tIns="53116" rIns="106260" bIns="53116" anchor="t" anchorCtr="0">
                  <a:spAutoFit/>
                </a:bodyPr>
                <a:lstStyle/>
                <a:p>
                  <a:r>
                    <a:rPr lang="en-US" sz="700" b="1" dirty="0">
                      <a:solidFill>
                        <a:schemeClr val="dk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       20        30       40       50        60       70</a:t>
                  </a:r>
                  <a:endParaRPr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D28409DB-A191-4C28-AD2E-EE117EB0BB11}"/>
                  </a:ext>
                </a:extLst>
              </p:cNvPr>
              <p:cNvSpPr/>
              <p:nvPr/>
            </p:nvSpPr>
            <p:spPr>
              <a:xfrm>
                <a:off x="725758" y="2435458"/>
                <a:ext cx="2116946" cy="1484653"/>
              </a:xfrm>
              <a:prstGeom prst="rect">
                <a:avLst/>
              </a:prstGeom>
              <a:grpFill/>
              <a:ln w="19050">
                <a:solidFill>
                  <a:srgbClr val="FF818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" name="Google Shape;1092;p14">
              <a:extLst>
                <a:ext uri="{FF2B5EF4-FFF2-40B4-BE49-F238E27FC236}">
                  <a16:creationId xmlns:a16="http://schemas.microsoft.com/office/drawing/2014/main" id="{6EDEE469-7D18-4024-B97C-DEEA396083A9}"/>
                </a:ext>
              </a:extLst>
            </p:cNvPr>
            <p:cNvSpPr txBox="1"/>
            <p:nvPr/>
          </p:nvSpPr>
          <p:spPr>
            <a:xfrm>
              <a:off x="2973095" y="632188"/>
              <a:ext cx="358410" cy="36375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>
                <a:lnSpc>
                  <a:spcPts val="1976"/>
                </a:lnSpc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Google Shape;1251;p18">
              <a:extLst>
                <a:ext uri="{FF2B5EF4-FFF2-40B4-BE49-F238E27FC236}">
                  <a16:creationId xmlns:a16="http://schemas.microsoft.com/office/drawing/2014/main" id="{A015A6B8-0C86-4B24-B836-4A192B5A4FA8}"/>
                </a:ext>
              </a:extLst>
            </p:cNvPr>
            <p:cNvPicPr preferRelativeResize="0"/>
            <p:nvPr/>
          </p:nvPicPr>
          <p:blipFill rotWithShape="1">
            <a:blip r:embed="rId4">
              <a:alphaModFix/>
            </a:blip>
            <a:srcRect l="4927"/>
            <a:stretch/>
          </p:blipFill>
          <p:spPr>
            <a:xfrm>
              <a:off x="3222514" y="684658"/>
              <a:ext cx="3158267" cy="93980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" name="Google Shape;1069;p14">
              <a:extLst>
                <a:ext uri="{FF2B5EF4-FFF2-40B4-BE49-F238E27FC236}">
                  <a16:creationId xmlns:a16="http://schemas.microsoft.com/office/drawing/2014/main" id="{E8F7507D-9D33-40DB-8BB2-CA418B655D64}"/>
                </a:ext>
              </a:extLst>
            </p:cNvPr>
            <p:cNvSpPr txBox="1"/>
            <p:nvPr/>
          </p:nvSpPr>
          <p:spPr>
            <a:xfrm>
              <a:off x="3477895" y="1443396"/>
              <a:ext cx="3013409" cy="214991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               20             40             60              80            100           120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8F5FA682-248B-4077-AF44-30A6716380FE}"/>
                </a:ext>
              </a:extLst>
            </p:cNvPr>
            <p:cNvSpPr/>
            <p:nvPr/>
          </p:nvSpPr>
          <p:spPr>
            <a:xfrm>
              <a:off x="3286236" y="724516"/>
              <a:ext cx="3046735" cy="661061"/>
            </a:xfrm>
            <a:prstGeom prst="rect">
              <a:avLst/>
            </a:prstGeom>
            <a:noFill/>
            <a:ln w="19050">
              <a:solidFill>
                <a:srgbClr val="59D8D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203755E2-1851-4DFB-A0E8-C8A99DAD07A2}"/>
                </a:ext>
              </a:extLst>
            </p:cNvPr>
            <p:cNvGrpSpPr/>
            <p:nvPr/>
          </p:nvGrpSpPr>
          <p:grpSpPr>
            <a:xfrm>
              <a:off x="3185075" y="2628231"/>
              <a:ext cx="3218409" cy="1008641"/>
              <a:chOff x="3586343" y="4798823"/>
              <a:chExt cx="3688195" cy="1023377"/>
            </a:xfrm>
            <a:noFill/>
          </p:grpSpPr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7B923EB5-B304-4CEE-A602-FD65613A5704}"/>
                  </a:ext>
                </a:extLst>
              </p:cNvPr>
              <p:cNvGrpSpPr/>
              <p:nvPr/>
            </p:nvGrpSpPr>
            <p:grpSpPr>
              <a:xfrm>
                <a:off x="3586343" y="4798823"/>
                <a:ext cx="3688195" cy="1023377"/>
                <a:chOff x="2807712" y="4263587"/>
                <a:chExt cx="3688195" cy="1023377"/>
              </a:xfrm>
              <a:grpFill/>
            </p:grpSpPr>
            <p:sp>
              <p:nvSpPr>
                <p:cNvPr id="41" name="Google Shape;1069;p14">
                  <a:extLst>
                    <a:ext uri="{FF2B5EF4-FFF2-40B4-BE49-F238E27FC236}">
                      <a16:creationId xmlns:a16="http://schemas.microsoft.com/office/drawing/2014/main" id="{87712BC4-5D84-453E-8134-5A6565433A17}"/>
                    </a:ext>
                  </a:extLst>
                </p:cNvPr>
                <p:cNvSpPr txBox="1"/>
                <p:nvPr/>
              </p:nvSpPr>
              <p:spPr>
                <a:xfrm>
                  <a:off x="3138471" y="5060369"/>
                  <a:ext cx="3098137" cy="226595"/>
                </a:xfrm>
                <a:prstGeom prst="rect">
                  <a:avLst/>
                </a:prstGeom>
                <a:grpFill/>
                <a:ln>
                  <a:noFill/>
                </a:ln>
              </p:spPr>
              <p:txBody>
                <a:bodyPr spcFirstLastPara="1" wrap="square" lIns="106260" tIns="53116" rIns="106260" bIns="53116" anchor="t" anchorCtr="0">
                  <a:spAutoFit/>
                </a:bodyPr>
                <a:lstStyle/>
                <a:p>
                  <a:r>
                    <a:rPr lang="en-US" sz="700" b="1" dirty="0">
                      <a:solidFill>
                        <a:schemeClr val="dk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        20              40               60              80              100</a:t>
                  </a:r>
                  <a:endParaRPr sz="700" b="1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42" name="Google Shape;1252;p18">
                  <a:extLst>
                    <a:ext uri="{FF2B5EF4-FFF2-40B4-BE49-F238E27FC236}">
                      <a16:creationId xmlns:a16="http://schemas.microsoft.com/office/drawing/2014/main" id="{56A229BA-C0A9-4D3E-BB5F-6826A31A5CCC}"/>
                    </a:ext>
                  </a:extLst>
                </p:cNvPr>
                <p:cNvPicPr preferRelativeResize="0"/>
                <p:nvPr/>
              </p:nvPicPr>
              <p:blipFill rotWithShape="1">
                <a:blip r:embed="rId5">
                  <a:alphaModFix/>
                </a:blip>
                <a:srcRect l="3419" b="12210"/>
                <a:stretch/>
              </p:blipFill>
              <p:spPr>
                <a:xfrm>
                  <a:off x="2807712" y="4263587"/>
                  <a:ext cx="3688195" cy="861306"/>
                </a:xfrm>
                <a:prstGeom prst="rect">
                  <a:avLst/>
                </a:prstGeom>
                <a:grpFill/>
                <a:ln>
                  <a:noFill/>
                </a:ln>
              </p:spPr>
            </p:pic>
          </p:grpSp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B9802CE9-EFC1-48D9-9484-CED8A82C216A}"/>
                  </a:ext>
                </a:extLst>
              </p:cNvPr>
              <p:cNvSpPr/>
              <p:nvPr/>
            </p:nvSpPr>
            <p:spPr>
              <a:xfrm>
                <a:off x="3686219" y="4846256"/>
                <a:ext cx="3533742" cy="688049"/>
              </a:xfrm>
              <a:prstGeom prst="rect">
                <a:avLst/>
              </a:prstGeom>
              <a:grpFill/>
              <a:ln w="19050">
                <a:solidFill>
                  <a:srgbClr val="FF818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F803E12-BF1E-49BF-B688-21563494F2BC}"/>
                </a:ext>
              </a:extLst>
            </p:cNvPr>
            <p:cNvSpPr txBox="1"/>
            <p:nvPr/>
          </p:nvSpPr>
          <p:spPr>
            <a:xfrm>
              <a:off x="1238319" y="3956879"/>
              <a:ext cx="1136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bscissa coordinates </a:t>
              </a:r>
              <a:endParaRPr lang="en-AU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7520C4E-AEAC-453A-A665-DAEF8915E8F3}"/>
                </a:ext>
              </a:extLst>
            </p:cNvPr>
            <p:cNvSpPr txBox="1"/>
            <p:nvPr/>
          </p:nvSpPr>
          <p:spPr>
            <a:xfrm rot="16200000">
              <a:off x="-214054" y="1987945"/>
              <a:ext cx="11144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Ordinate coordinates </a:t>
              </a:r>
              <a:endParaRPr lang="en-AU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Google Shape;1253;p18">
              <a:extLst>
                <a:ext uri="{FF2B5EF4-FFF2-40B4-BE49-F238E27FC236}">
                  <a16:creationId xmlns:a16="http://schemas.microsoft.com/office/drawing/2014/main" id="{FC43BF74-0809-40E2-B2AF-4A96548665A1}"/>
                </a:ext>
              </a:extLst>
            </p:cNvPr>
            <p:cNvSpPr txBox="1"/>
            <p:nvPr/>
          </p:nvSpPr>
          <p:spPr>
            <a:xfrm>
              <a:off x="0" y="3071699"/>
              <a:ext cx="448601" cy="21499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  <a:endParaRPr sz="700" b="1" baseline="-250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Google Shape;1253;p18">
              <a:extLst>
                <a:ext uri="{FF2B5EF4-FFF2-40B4-BE49-F238E27FC236}">
                  <a16:creationId xmlns:a16="http://schemas.microsoft.com/office/drawing/2014/main" id="{11523995-915F-42DB-9F0F-BCBC605C0EB9}"/>
                </a:ext>
              </a:extLst>
            </p:cNvPr>
            <p:cNvSpPr txBox="1"/>
            <p:nvPr/>
          </p:nvSpPr>
          <p:spPr>
            <a:xfrm>
              <a:off x="828607" y="1"/>
              <a:ext cx="2396540" cy="21499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rdinal segmentation</a:t>
              </a:r>
              <a:endParaRPr sz="700" b="1" baseline="-250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FEA3018-589A-4B8D-96D9-E43DA822E33A}"/>
                </a:ext>
              </a:extLst>
            </p:cNvPr>
            <p:cNvSpPr txBox="1"/>
            <p:nvPr/>
          </p:nvSpPr>
          <p:spPr>
            <a:xfrm>
              <a:off x="2672" y="1"/>
              <a:ext cx="242374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CB0535A-CC5F-413E-9C69-178ADE7A1BF4}"/>
                </a:ext>
              </a:extLst>
            </p:cNvPr>
            <p:cNvSpPr txBox="1"/>
            <p:nvPr/>
          </p:nvSpPr>
          <p:spPr>
            <a:xfrm>
              <a:off x="3040763" y="-4297"/>
              <a:ext cx="247184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2" name="Google Shape;1253;p18">
              <a:extLst>
                <a:ext uri="{FF2B5EF4-FFF2-40B4-BE49-F238E27FC236}">
                  <a16:creationId xmlns:a16="http://schemas.microsoft.com/office/drawing/2014/main" id="{88A9DB42-04E5-4506-8C7A-7B54DAF086DF}"/>
                </a:ext>
              </a:extLst>
            </p:cNvPr>
            <p:cNvSpPr txBox="1"/>
            <p:nvPr/>
          </p:nvSpPr>
          <p:spPr>
            <a:xfrm>
              <a:off x="3836523" y="30509"/>
              <a:ext cx="2396540" cy="21499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ineticMSI segmentation</a:t>
              </a:r>
              <a:endParaRPr sz="700" b="1" baseline="-250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Google Shape;1045;p14">
              <a:extLst>
                <a:ext uri="{FF2B5EF4-FFF2-40B4-BE49-F238E27FC236}">
                  <a16:creationId xmlns:a16="http://schemas.microsoft.com/office/drawing/2014/main" id="{79784B27-30C3-47A8-88B0-8C9A3452C415}"/>
                </a:ext>
              </a:extLst>
            </p:cNvPr>
            <p:cNvSpPr txBox="1"/>
            <p:nvPr/>
          </p:nvSpPr>
          <p:spPr>
            <a:xfrm>
              <a:off x="427462" y="2071664"/>
              <a:ext cx="346959" cy="56893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r">
                <a:lnSpc>
                  <a:spcPts val="930"/>
                </a:lnSpc>
              </a:pPr>
              <a:endParaRPr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930"/>
                </a:lnSpc>
              </a:pP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930"/>
                </a:lnSpc>
              </a:pP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930"/>
                </a:lnSpc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Google Shape;1045;p14">
              <a:extLst>
                <a:ext uri="{FF2B5EF4-FFF2-40B4-BE49-F238E27FC236}">
                  <a16:creationId xmlns:a16="http://schemas.microsoft.com/office/drawing/2014/main" id="{1D6431A9-FCDE-41C8-8C8F-4A870B084343}"/>
                </a:ext>
              </a:extLst>
            </p:cNvPr>
            <p:cNvSpPr txBox="1"/>
            <p:nvPr/>
          </p:nvSpPr>
          <p:spPr>
            <a:xfrm>
              <a:off x="427462" y="2818996"/>
              <a:ext cx="346959" cy="22268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r">
                <a:lnSpc>
                  <a:spcPts val="930"/>
                </a:lnSpc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Google Shape;1045;p14">
              <a:extLst>
                <a:ext uri="{FF2B5EF4-FFF2-40B4-BE49-F238E27FC236}">
                  <a16:creationId xmlns:a16="http://schemas.microsoft.com/office/drawing/2014/main" id="{EC51891B-EBE2-4B27-BAA0-685136B768D9}"/>
                </a:ext>
              </a:extLst>
            </p:cNvPr>
            <p:cNvSpPr txBox="1"/>
            <p:nvPr/>
          </p:nvSpPr>
          <p:spPr>
            <a:xfrm>
              <a:off x="427461" y="3215502"/>
              <a:ext cx="346959" cy="22268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r">
                <a:lnSpc>
                  <a:spcPts val="930"/>
                </a:lnSpc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sz="700" b="1" baseline="300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Google Shape;1045;p14">
              <a:extLst>
                <a:ext uri="{FF2B5EF4-FFF2-40B4-BE49-F238E27FC236}">
                  <a16:creationId xmlns:a16="http://schemas.microsoft.com/office/drawing/2014/main" id="{5786D02A-49A1-47D2-978E-48E1E771A229}"/>
                </a:ext>
              </a:extLst>
            </p:cNvPr>
            <p:cNvSpPr txBox="1"/>
            <p:nvPr/>
          </p:nvSpPr>
          <p:spPr>
            <a:xfrm>
              <a:off x="427460" y="3619232"/>
              <a:ext cx="346959" cy="22268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r">
                <a:lnSpc>
                  <a:spcPts val="930"/>
                </a:lnSpc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E6F87AED-3396-4EDA-A700-0118EFCDAFC2}"/>
                </a:ext>
              </a:extLst>
            </p:cNvPr>
            <p:cNvSpPr/>
            <p:nvPr/>
          </p:nvSpPr>
          <p:spPr>
            <a:xfrm>
              <a:off x="2660650" y="378083"/>
              <a:ext cx="219024" cy="2791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C0107195-5D63-4C64-82B2-8B16A0454372}"/>
                </a:ext>
              </a:extLst>
            </p:cNvPr>
            <p:cNvSpPr/>
            <p:nvPr/>
          </p:nvSpPr>
          <p:spPr>
            <a:xfrm>
              <a:off x="2666205" y="2224444"/>
              <a:ext cx="219024" cy="2791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9" name="Google Shape;1250;p18" descr="Chart&#10;&#10;Description automatically generated">
              <a:extLst>
                <a:ext uri="{FF2B5EF4-FFF2-40B4-BE49-F238E27FC236}">
                  <a16:creationId xmlns:a16="http://schemas.microsoft.com/office/drawing/2014/main" id="{0C95B4A0-1020-4AD1-8B48-35B162DA7C9E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l="91608" t="9558" r="4886" b="82733"/>
            <a:stretch/>
          </p:blipFill>
          <p:spPr>
            <a:xfrm>
              <a:off x="2484795" y="2261412"/>
              <a:ext cx="240091" cy="296628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0" name="Google Shape;1092;p14">
              <a:extLst>
                <a:ext uri="{FF2B5EF4-FFF2-40B4-BE49-F238E27FC236}">
                  <a16:creationId xmlns:a16="http://schemas.microsoft.com/office/drawing/2014/main" id="{E9A3211F-A889-4E03-BA74-87E9242E75AD}"/>
                </a:ext>
              </a:extLst>
            </p:cNvPr>
            <p:cNvSpPr txBox="1"/>
            <p:nvPr/>
          </p:nvSpPr>
          <p:spPr>
            <a:xfrm>
              <a:off x="2544086" y="2240675"/>
              <a:ext cx="358410" cy="33810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de-DE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endParaRPr lang="de-DE" sz="5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Google Shape;1250;p18" descr="Chart&#10;&#10;Description automatically generated">
              <a:extLst>
                <a:ext uri="{FF2B5EF4-FFF2-40B4-BE49-F238E27FC236}">
                  <a16:creationId xmlns:a16="http://schemas.microsoft.com/office/drawing/2014/main" id="{A458817A-DF93-4A5A-B62F-E8CCC4617312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l="91608" t="9558" r="4886" b="82733"/>
            <a:stretch/>
          </p:blipFill>
          <p:spPr>
            <a:xfrm>
              <a:off x="2487369" y="414049"/>
              <a:ext cx="240091" cy="296628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2" name="Google Shape;1092;p14">
              <a:extLst>
                <a:ext uri="{FF2B5EF4-FFF2-40B4-BE49-F238E27FC236}">
                  <a16:creationId xmlns:a16="http://schemas.microsoft.com/office/drawing/2014/main" id="{508FAC3D-FA34-45D1-8E37-4C6C15E3C02C}"/>
                </a:ext>
              </a:extLst>
            </p:cNvPr>
            <p:cNvSpPr txBox="1"/>
            <p:nvPr/>
          </p:nvSpPr>
          <p:spPr>
            <a:xfrm>
              <a:off x="2542617" y="395781"/>
              <a:ext cx="358410" cy="33810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de-DE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endParaRPr lang="de-DE" sz="5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Google Shape;1092;p14">
              <a:extLst>
                <a:ext uri="{FF2B5EF4-FFF2-40B4-BE49-F238E27FC236}">
                  <a16:creationId xmlns:a16="http://schemas.microsoft.com/office/drawing/2014/main" id="{84B0D7E5-CCD4-497D-BC9C-A23F47D77EC1}"/>
                </a:ext>
              </a:extLst>
            </p:cNvPr>
            <p:cNvSpPr txBox="1"/>
            <p:nvPr/>
          </p:nvSpPr>
          <p:spPr>
            <a:xfrm>
              <a:off x="2973095" y="1117633"/>
              <a:ext cx="358410" cy="36375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>
                <a:lnSpc>
                  <a:spcPts val="1976"/>
                </a:lnSpc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Google Shape;1092;p14">
              <a:extLst>
                <a:ext uri="{FF2B5EF4-FFF2-40B4-BE49-F238E27FC236}">
                  <a16:creationId xmlns:a16="http://schemas.microsoft.com/office/drawing/2014/main" id="{2FE22CAE-42BD-4D38-8BE8-C105FA94336A}"/>
                </a:ext>
              </a:extLst>
            </p:cNvPr>
            <p:cNvSpPr txBox="1"/>
            <p:nvPr/>
          </p:nvSpPr>
          <p:spPr>
            <a:xfrm>
              <a:off x="2973095" y="874910"/>
              <a:ext cx="358410" cy="36375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>
                <a:lnSpc>
                  <a:spcPts val="1976"/>
                </a:lnSpc>
              </a:pPr>
              <a:r>
                <a:rPr lang="de-DE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Google Shape;1092;p14">
              <a:extLst>
                <a:ext uri="{FF2B5EF4-FFF2-40B4-BE49-F238E27FC236}">
                  <a16:creationId xmlns:a16="http://schemas.microsoft.com/office/drawing/2014/main" id="{470C898F-9D64-41C8-9E4E-6E724F251DD3}"/>
                </a:ext>
              </a:extLst>
            </p:cNvPr>
            <p:cNvSpPr txBox="1"/>
            <p:nvPr/>
          </p:nvSpPr>
          <p:spPr>
            <a:xfrm>
              <a:off x="2969163" y="2599237"/>
              <a:ext cx="358410" cy="36375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>
                <a:lnSpc>
                  <a:spcPts val="1976"/>
                </a:lnSpc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Google Shape;1092;p14">
              <a:extLst>
                <a:ext uri="{FF2B5EF4-FFF2-40B4-BE49-F238E27FC236}">
                  <a16:creationId xmlns:a16="http://schemas.microsoft.com/office/drawing/2014/main" id="{A2016D01-F588-424B-A754-0C46BAA8FAA9}"/>
                </a:ext>
              </a:extLst>
            </p:cNvPr>
            <p:cNvSpPr txBox="1"/>
            <p:nvPr/>
          </p:nvSpPr>
          <p:spPr>
            <a:xfrm>
              <a:off x="2969163" y="3071699"/>
              <a:ext cx="358410" cy="36375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>
                <a:lnSpc>
                  <a:spcPts val="1976"/>
                </a:lnSpc>
              </a:pP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Google Shape;1092;p14">
              <a:extLst>
                <a:ext uri="{FF2B5EF4-FFF2-40B4-BE49-F238E27FC236}">
                  <a16:creationId xmlns:a16="http://schemas.microsoft.com/office/drawing/2014/main" id="{B6F9DF7A-6FA8-4E70-8D7E-5C5F95CEE86D}"/>
                </a:ext>
              </a:extLst>
            </p:cNvPr>
            <p:cNvSpPr txBox="1"/>
            <p:nvPr/>
          </p:nvSpPr>
          <p:spPr>
            <a:xfrm>
              <a:off x="2969163" y="2835468"/>
              <a:ext cx="358410" cy="36375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>
                <a:lnSpc>
                  <a:spcPts val="1976"/>
                </a:lnSpc>
              </a:pPr>
              <a:r>
                <a:rPr lang="de-DE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24F53AD-4074-4801-AC6F-1FD0C3A62066}"/>
                </a:ext>
              </a:extLst>
            </p:cNvPr>
            <p:cNvSpPr txBox="1"/>
            <p:nvPr/>
          </p:nvSpPr>
          <p:spPr>
            <a:xfrm>
              <a:off x="4225854" y="3551851"/>
              <a:ext cx="1136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bscissa coordinates </a:t>
              </a:r>
              <a:endParaRPr lang="en-AU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582818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68</Words>
  <Application>Microsoft Office PowerPoint</Application>
  <PresentationFormat>Custom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rheen Farzana</dc:creator>
  <cp:lastModifiedBy>Farheen Farzana</cp:lastModifiedBy>
  <cp:revision>2</cp:revision>
  <dcterms:created xsi:type="dcterms:W3CDTF">2022-04-16T06:26:08Z</dcterms:created>
  <dcterms:modified xsi:type="dcterms:W3CDTF">2022-04-18T02:04:52Z</dcterms:modified>
</cp:coreProperties>
</file>